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30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E31132CD-A6F4-6848-93D1-41D9BC39EC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2935" y="2010147"/>
            <a:ext cx="8850697" cy="4720372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0DD0BFA2-B515-BF49-A166-E518E9118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90" y="576221"/>
            <a:ext cx="10962290" cy="512256"/>
          </a:xfrm>
        </p:spPr>
        <p:txBody>
          <a:bodyPr>
            <a:noAutofit/>
          </a:bodyPr>
          <a:lstStyle/>
          <a:p>
            <a:r>
              <a:rPr lang="en-US" sz="32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1</a:t>
            </a:r>
          </a:p>
        </p:txBody>
      </p:sp>
      <p:sp>
        <p:nvSpPr>
          <p:cNvPr id="8" name="Content Placeholder 1">
            <a:extLst>
              <a:ext uri="{FF2B5EF4-FFF2-40B4-BE49-F238E27FC236}">
                <a16:creationId xmlns:a16="http://schemas.microsoft.com/office/drawing/2014/main" id="{866D60E8-A700-B242-BCFE-B00642F84344}"/>
              </a:ext>
            </a:extLst>
          </p:cNvPr>
          <p:cNvSpPr txBox="1">
            <a:spLocks/>
          </p:cNvSpPr>
          <p:nvPr/>
        </p:nvSpPr>
        <p:spPr>
          <a:xfrm>
            <a:off x="274590" y="1891859"/>
            <a:ext cx="2845995" cy="299782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Propensity Weighting and Balance Adjustment: TMB.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The pre- and post-adjustment balance for (A) 2</a:t>
            </a:r>
            <a:r>
              <a:rPr lang="en-US" sz="1400" baseline="3000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 line cohort with TMB &lt; 10, (B) 2</a:t>
            </a:r>
            <a:r>
              <a:rPr lang="en-US" sz="1400" baseline="3000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 line cohort with TMB 10 or greater, (C) 1</a:t>
            </a:r>
            <a:r>
              <a:rPr lang="en-US" sz="1400" baseline="30000">
                <a:latin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 line cohort with TMB &lt; 10, (D) 1</a:t>
            </a:r>
            <a:r>
              <a:rPr lang="en-US" sz="1400" baseline="30000">
                <a:latin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 line cohort with TMB 10 or greater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CDBCD6-BCFD-2D43-9B34-B97BAC1A26B4}"/>
              </a:ext>
            </a:extLst>
          </p:cNvPr>
          <p:cNvSpPr txBox="1"/>
          <p:nvPr/>
        </p:nvSpPr>
        <p:spPr>
          <a:xfrm>
            <a:off x="3341303" y="1860956"/>
            <a:ext cx="4908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7789146-4F5C-634B-AD68-538905B78748}"/>
              </a:ext>
            </a:extLst>
          </p:cNvPr>
          <p:cNvSpPr txBox="1"/>
          <p:nvPr/>
        </p:nvSpPr>
        <p:spPr>
          <a:xfrm>
            <a:off x="7896946" y="1860956"/>
            <a:ext cx="481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C6E1A1-C0AC-8042-A88D-9BBD552E0E05}"/>
              </a:ext>
            </a:extLst>
          </p:cNvPr>
          <p:cNvSpPr txBox="1"/>
          <p:nvPr/>
        </p:nvSpPr>
        <p:spPr>
          <a:xfrm>
            <a:off x="3341303" y="4370333"/>
            <a:ext cx="4780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6F43C99-F133-FC48-9362-58B2DCBAECF7}"/>
              </a:ext>
            </a:extLst>
          </p:cNvPr>
          <p:cNvSpPr txBox="1"/>
          <p:nvPr/>
        </p:nvSpPr>
        <p:spPr>
          <a:xfrm>
            <a:off x="7896946" y="4370333"/>
            <a:ext cx="4988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3560951409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75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4</cp:revision>
  <dcterms:created xsi:type="dcterms:W3CDTF">2022-06-12T16:24:02Z</dcterms:created>
  <dcterms:modified xsi:type="dcterms:W3CDTF">2022-08-13T14:32:49Z</dcterms:modified>
</cp:coreProperties>
</file>